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11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08C849-C5D3-BC74-A69C-AD79D34586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A81DE43-3B77-F07F-A26D-908DFF445F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22392F-5956-E8A2-F5A1-C7A5F2610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24D0CB2-58DF-F497-6E67-4CDFFF75A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E3E868-5EFE-1215-DFBD-EA7E3BBD4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986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A493B6-4AEC-5D00-CD7C-436E9125B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993D7B7-5902-05C2-7DD1-3AD6652C51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08AC97-86FF-C773-00CB-47074C049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381F42-08DC-C076-1CDF-B9329DA3D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5A8A65-9A33-B401-48EA-97DBFD22B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6182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00B0DA2-2723-8D71-1FE3-1DFE5AF934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97601C7-BEBF-2D92-E0EE-D9BF61F19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9BD088B-9F43-3B38-2058-EC5440512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A75DA4-45D3-1751-D0A8-460AFE619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F33800-02AE-5BF1-0C50-96A29B642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9422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820BFB-E883-B657-65B9-9BA3F0EADA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C9682AC-1A18-A801-0D84-4E27A3AFF5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8A41DB-F803-60FB-99E0-E99182412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B984EA-4553-E6DC-93AB-0BE246DAD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F3BAA8-DA7F-63CE-91C3-741C10BA2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7419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D984B-A460-A92F-D85F-C402B5EA0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F2B132D-54E1-2D97-0BC0-B34F497F1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E176B6-B42C-184A-E6F0-7932E5334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4FED95D-5966-CE6E-E863-792BE1CA8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B4A4BF-2FE4-26C4-DEA4-C326071EF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046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8B61E7-8B00-73C4-0B38-EACD151FD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AF2048A-0B21-6D52-07A3-91A6225196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3744A9C-1163-8273-20CA-5A36EFCF1F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4850128-8A1C-49C3-D377-809E263E4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6101478-A298-DED6-AF2A-576D48E2B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3F9C1B7-1A9D-4ABE-872E-4A0E6EAB5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8751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86A49D-9649-FC18-F7D4-7B4426CE6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E57CB6F-B513-0806-B44D-1CEE494E3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6EEEAAD-3449-C8E4-4073-92EFF93C16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9C039A9-E3A7-AC38-9397-B2F80C8F76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22384FC-F7E9-3A5F-184C-3E7F1D8DBC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527200E-0AC5-7322-D8B9-00E276D01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DC1FE07-F537-9CF9-2278-5FCE361CB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BA4D424-AFB0-E7FF-BEBE-9BB5273D0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7336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AF2EEB-4AD4-D2A4-6AAA-86BCCBAD6A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A6E80F3-2E89-9E65-00A5-13D43B512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C86DA8B-B8A3-CD20-2495-DC794EE16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C772A4D-C196-C6B8-C77D-1ACB235A5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0859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0523264-7066-3D95-6208-ED53C5F3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B94F1E4-25FC-7E55-C223-800990C03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D09919F-DE63-77B3-9A80-C26D826E6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143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7DC40E-25C8-E508-2989-27E0B4677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1B161E-F43A-FAF5-CF95-2FECE56288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21EDF45-7C31-2E16-DC75-FD7AA0CABE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69F8FB1-C2FF-0FCC-3A0E-CC5A70F72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631C04-CB13-7FF5-7803-F99539025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AA80456-6455-F392-3E68-4D0D22C451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563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152437-243F-2F43-6B6E-28F5E277E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BEAC857-4958-3BCD-127F-501800B739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74C58C3-016E-19AB-5925-93D4C6ACEA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4D39F13-1FD4-D3FE-EF38-EFC3317F9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C0D088-F2A2-85F0-CD4C-7A41CB918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9ED6DD1-233A-1A5D-DD54-1C2699700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4609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954533F-4D59-1CF3-19B8-35007B059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6EF467A-8999-2234-D048-70FF6B41D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565F20-A48A-C901-016E-2131692E25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6862D5-0D3B-A0B8-8105-F51E0A6E35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123C0D-9D32-B830-67A6-E76F44F31D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401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Image 41" descr="Une image contenant texte&#10;&#10;Description générée automatiquement">
            <a:extLst>
              <a:ext uri="{FF2B5EF4-FFF2-40B4-BE49-F238E27FC236}">
                <a16:creationId xmlns:a16="http://schemas.microsoft.com/office/drawing/2014/main" id="{F7BA40C1-C75E-D1C5-7C82-AE7A0026A44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19"/>
          <a:stretch/>
        </p:blipFill>
        <p:spPr>
          <a:xfrm>
            <a:off x="5325193" y="3318171"/>
            <a:ext cx="3707743" cy="27244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Image 39" descr="Une image contenant carte&#10;&#10;Description générée automatiquement">
            <a:extLst>
              <a:ext uri="{FF2B5EF4-FFF2-40B4-BE49-F238E27FC236}">
                <a16:creationId xmlns:a16="http://schemas.microsoft.com/office/drawing/2014/main" id="{70320A37-F980-0433-01EA-CC6B055F5C1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753"/>
          <a:stretch/>
        </p:blipFill>
        <p:spPr>
          <a:xfrm>
            <a:off x="1459963" y="3314700"/>
            <a:ext cx="3707744" cy="27518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Image 37" descr="Une image contenant carte&#10;&#10;Description générée automatiquement">
            <a:extLst>
              <a:ext uri="{FF2B5EF4-FFF2-40B4-BE49-F238E27FC236}">
                <a16:creationId xmlns:a16="http://schemas.microsoft.com/office/drawing/2014/main" id="{33C79122-ADD0-AA1F-BA16-4431C27A0CA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75"/>
          <a:stretch/>
        </p:blipFill>
        <p:spPr>
          <a:xfrm>
            <a:off x="5325193" y="445037"/>
            <a:ext cx="3673307" cy="27518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Image 35" descr="Une image contenant texte&#10;&#10;Description générée automatiquement">
            <a:extLst>
              <a:ext uri="{FF2B5EF4-FFF2-40B4-BE49-F238E27FC236}">
                <a16:creationId xmlns:a16="http://schemas.microsoft.com/office/drawing/2014/main" id="{D65DAE8C-8106-DBA1-D274-168D7C40DE8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73"/>
          <a:stretch/>
        </p:blipFill>
        <p:spPr>
          <a:xfrm>
            <a:off x="1473598" y="436040"/>
            <a:ext cx="3673605" cy="27518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E61AA91B-1B03-6DB2-4D56-00C8AD43E736}"/>
              </a:ext>
            </a:extLst>
          </p:cNvPr>
          <p:cNvSpPr txBox="1"/>
          <p:nvPr/>
        </p:nvSpPr>
        <p:spPr>
          <a:xfrm>
            <a:off x="-198120" y="6200361"/>
            <a:ext cx="8892540" cy="4431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indent="269875" algn="ctr">
              <a:lnSpc>
                <a:spcPct val="95000"/>
              </a:lnSpc>
              <a:spcAft>
                <a:spcPts val="800"/>
              </a:spcAft>
              <a:tabLst>
                <a:tab pos="3379470" algn="l"/>
              </a:tabLst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istological pictures of actinic keratoses (AK) that were classified by the transcriptomic analysis as “</a:t>
            </a:r>
            <a:r>
              <a:rPr lang="en-US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sional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 (AK_L).</a:t>
            </a:r>
            <a:endParaRPr lang="fr-FR" sz="12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C7D7CF7-13DC-690A-7C73-433F543F244D}"/>
              </a:ext>
            </a:extLst>
          </p:cNvPr>
          <p:cNvSpPr/>
          <p:nvPr/>
        </p:nvSpPr>
        <p:spPr>
          <a:xfrm>
            <a:off x="1481218" y="2960433"/>
            <a:ext cx="1208642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56_B_AK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8791660-E67F-2F67-1598-3F13FE36113E}"/>
              </a:ext>
            </a:extLst>
          </p:cNvPr>
          <p:cNvSpPr/>
          <p:nvPr/>
        </p:nvSpPr>
        <p:spPr>
          <a:xfrm>
            <a:off x="5337774" y="5819675"/>
            <a:ext cx="1304207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9_C_AK_1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3176B2D-6B7E-D45B-0C07-D24AA3EA79D4}"/>
              </a:ext>
            </a:extLst>
          </p:cNvPr>
          <p:cNvSpPr/>
          <p:nvPr/>
        </p:nvSpPr>
        <p:spPr>
          <a:xfrm>
            <a:off x="5337774" y="2968053"/>
            <a:ext cx="1200186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82_al_AK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E8870D2-6971-B560-2C6C-A51DB9BEC96B}"/>
              </a:ext>
            </a:extLst>
          </p:cNvPr>
          <p:cNvSpPr/>
          <p:nvPr/>
        </p:nvSpPr>
        <p:spPr>
          <a:xfrm>
            <a:off x="1467583" y="5846620"/>
            <a:ext cx="1229897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5_F_AK</a:t>
            </a:r>
          </a:p>
        </p:txBody>
      </p:sp>
    </p:spTree>
    <p:extLst>
      <p:ext uri="{BB962C8B-B14F-4D97-AF65-F5344CB8AC3E}">
        <p14:creationId xmlns:p14="http://schemas.microsoft.com/office/powerpoint/2010/main" val="29611142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49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Dubois-Pot-Schneider</dc:creator>
  <cp:lastModifiedBy>Helene Dubois-Pot-Schneider</cp:lastModifiedBy>
  <cp:revision>5</cp:revision>
  <cp:lastPrinted>2023-02-20T14:18:20Z</cp:lastPrinted>
  <dcterms:created xsi:type="dcterms:W3CDTF">2023-02-20T13:58:04Z</dcterms:created>
  <dcterms:modified xsi:type="dcterms:W3CDTF">2023-02-21T14:20:27Z</dcterms:modified>
</cp:coreProperties>
</file>